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jpeg" ContentType="image/jpeg"/>
  <Override PartName="/ppt/media/image7.jpeg" ContentType="image/jpe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</p:sldIdLst>
  <p:sldSz cx="10080625" cy="7559675"/>
  <p:notesSz cx="7772400" cy="100584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5D1A9D-DF28-4089-8782-F31B6B777150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7092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502920" y="4374000"/>
            <a:ext cx="907092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F8641F3-62C0-4E9F-AC78-32FF8BD9B76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515124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B62A904-6448-4268-A30E-08C20D059A1A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570120" y="176832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636960" y="176832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502920" y="437400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570120" y="437400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636960" y="4374000"/>
            <a:ext cx="292068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0CB9B4E-420A-48D1-9111-738B83DC2D7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502920" y="1768320"/>
            <a:ext cx="907092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3D168-AC70-4C82-9583-34E74ACCE2A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907092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D2BC9A-4D75-48AC-BBF9-58ED2DB6033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7250EF2-0369-40F9-BE19-1502D406F8C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EAF4038-6296-42E1-90E5-0C4B78F51AD0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502920" y="301320"/>
            <a:ext cx="9070920" cy="58435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7000"/>
              </a:lnSpc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A29B7E6-2D03-4121-B2AE-56661CEADF2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645EB11-231F-4C1F-B13A-3913D7C38DC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5151240" y="437400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8F1043-7B3A-4C9E-BBC0-2D7D3D3703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50292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5151240" y="1768320"/>
            <a:ext cx="442656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502920" y="4374000"/>
            <a:ext cx="9070920" cy="2379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lnSpc>
                <a:spcPct val="97000"/>
              </a:lnSpc>
              <a:spcAft>
                <a:spcPts val="1426"/>
              </a:spcAft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5D71ED9-3038-4247-BF49-779445B84C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502920" y="301320"/>
            <a:ext cx="9070920" cy="12603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7000"/>
              </a:lnSpc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Bitstream Vera Sans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502920" y="1768320"/>
            <a:ext cx="9070920" cy="49881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marL="431640" indent="-32364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Bitstream Vera Sans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  <a:p>
            <a:pPr lvl="1" marL="863640" indent="-28728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Bitstream Vera Sans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  <a:p>
            <a:pPr lvl="2" marL="1295280" indent="-21564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Bitstream Vera Sans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  <a:p>
            <a:pPr lvl="3" marL="1727280" indent="-21600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75000"/>
              <a:buFont typeface="Symbol" charset="2"/>
              <a:buChar char="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Bitstream Vera Sans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  <a:p>
            <a:pPr lvl="4" marL="2158920" indent="-21564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Bitstream Vera Sans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  <a:p>
            <a:pPr lvl="5" marL="2158920" indent="-21564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Bitstream Vera Sans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  <a:p>
            <a:pPr lvl="6" marL="2158920" indent="-215640">
              <a:lnSpc>
                <a:spcPct val="97000"/>
              </a:lnSpc>
              <a:spcAft>
                <a:spcPts val="1426"/>
              </a:spcAft>
              <a:buClr>
                <a:srgbClr val="000000"/>
              </a:buClr>
              <a:buSzPct val="45000"/>
              <a:buFont typeface="Wingdings" charset="2"/>
              <a:buChar char="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Bitstream Vera Sans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502920" y="6886080"/>
            <a:ext cx="2346120" cy="5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>
              <a:lnSpc>
                <a:spcPct val="116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lnSpc>
                <a:spcPct val="116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448080" y="6886080"/>
            <a:ext cx="3193920" cy="5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ctr">
              <a:lnSpc>
                <a:spcPct val="116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lnSpc>
                <a:spcPct val="116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7226280" y="6886080"/>
            <a:ext cx="2346480" cy="520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lstStyle>
            <a:lvl1pPr indent="0" algn="r">
              <a:lnSpc>
                <a:spcPct val="116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lnSpc>
                <a:spcPct val="116000"/>
              </a:lnSpc>
              <a:buNone/>
              <a:tabLst>
                <a:tab algn="l" pos="0"/>
                <a:tab algn="l" pos="723960"/>
                <a:tab algn="l" pos="1447920"/>
                <a:tab algn="l" pos="217188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fld id="{0DBB75DE-3707-4E6E-A41D-525050D14654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2.png"/><Relationship Id="rId2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image" Target="../media/image4.png"/><Relationship Id="rId2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image" Target="../media/image6.jpeg"/><Relationship Id="rId2" Type="http://schemas.openxmlformats.org/officeDocument/2006/relationships/image" Target="../media/image7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-610920" y="3025800"/>
            <a:ext cx="10508760" cy="1423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Supplementary Material.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Pages 2-7 Graphs showing the components of eigenvectors 2 and 3 from each simulation.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Bitstream Vera Sans"/>
              </a:rPr>
              <a:t>Negative peaks appear showing the contribution of repulsive interactions to the global energy. </a:t>
            </a: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42" name=""/>
          <p:cNvSpPr/>
          <p:nvPr/>
        </p:nvSpPr>
        <p:spPr>
          <a:xfrm>
            <a:off x="1855800" y="457200"/>
            <a:ext cx="6602400" cy="11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Similar Folds with Different Stabilization Mechanisms: The Cases of Prion and Doppel Proteins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S. Colacino, G. Tiana, G. Colombo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  <p:sp>
        <p:nvSpPr>
          <p:cNvPr id="43" name=""/>
          <p:cNvSpPr/>
          <p:nvPr/>
        </p:nvSpPr>
        <p:spPr>
          <a:xfrm>
            <a:off x="-552600" y="4572000"/>
            <a:ext cx="11507040" cy="1689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Supplementary Material.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Pages 8 RMSD superposition matrices of the structures of the first 10 conformational clusters from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the 450K simulation.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  <a:p>
            <a:pPr>
              <a:lnSpc>
                <a:spcPct val="97000"/>
              </a:lnSpc>
              <a:tabLst>
                <a:tab algn="l" pos="0"/>
                <a:tab algn="l" pos="723960"/>
                <a:tab algn="l" pos="1447920"/>
                <a:tab algn="l" pos="2171880"/>
                <a:tab algn="l" pos="2895480"/>
                <a:tab algn="l" pos="3619440"/>
                <a:tab algn="l" pos="4343400"/>
                <a:tab algn="l" pos="5067360"/>
                <a:tab algn="l" pos="5791320"/>
                <a:tab algn="l" pos="6515280"/>
                <a:tab algn="l" pos="7238880"/>
                <a:tab algn="l" pos="7962840"/>
                <a:tab algn="l" pos="8686800"/>
                <a:tab algn="l" pos="9144000"/>
                <a:tab algn="l" pos="9601200"/>
                <a:tab algn="l" pos="10058400"/>
                <a:tab algn="l" pos="105156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Bitstream Vera Sans"/>
              </a:rPr>
              <a:t>Negative peaks appear showing the contribution of repulsive interactions to the global energy. </a:t>
            </a: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 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603440" y="687240"/>
            <a:ext cx="6729480" cy="660240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447840" y="457200"/>
            <a:ext cx="120636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PrP 310K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6" name="" descr=""/>
          <p:cNvPicPr/>
          <p:nvPr/>
        </p:nvPicPr>
        <p:blipFill>
          <a:blip r:embed="rId1"/>
          <a:stretch/>
        </p:blipFill>
        <p:spPr>
          <a:xfrm>
            <a:off x="1601640" y="696960"/>
            <a:ext cx="7560000" cy="6391080"/>
          </a:xfrm>
          <a:prstGeom prst="rect">
            <a:avLst/>
          </a:prstGeom>
          <a:ln w="0">
            <a:noFill/>
          </a:ln>
        </p:spPr>
      </p:pic>
      <p:sp>
        <p:nvSpPr>
          <p:cNvPr id="47" name=""/>
          <p:cNvSpPr/>
          <p:nvPr/>
        </p:nvSpPr>
        <p:spPr>
          <a:xfrm>
            <a:off x="448560" y="457200"/>
            <a:ext cx="120636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PrP 350K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8" name="" descr=""/>
          <p:cNvPicPr/>
          <p:nvPr/>
        </p:nvPicPr>
        <p:blipFill>
          <a:blip r:embed="rId1"/>
          <a:stretch/>
        </p:blipFill>
        <p:spPr>
          <a:xfrm>
            <a:off x="1601640" y="696960"/>
            <a:ext cx="7560000" cy="6391080"/>
          </a:xfrm>
          <a:prstGeom prst="rect">
            <a:avLst/>
          </a:prstGeom>
          <a:ln w="0">
            <a:noFill/>
          </a:ln>
        </p:spPr>
      </p:pic>
      <p:sp>
        <p:nvSpPr>
          <p:cNvPr id="49" name=""/>
          <p:cNvSpPr/>
          <p:nvPr/>
        </p:nvSpPr>
        <p:spPr>
          <a:xfrm>
            <a:off x="448560" y="457200"/>
            <a:ext cx="120636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PrP 450K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0" name="" descr=""/>
          <p:cNvPicPr/>
          <p:nvPr/>
        </p:nvPicPr>
        <p:blipFill>
          <a:blip r:embed="rId1"/>
          <a:stretch/>
        </p:blipFill>
        <p:spPr>
          <a:xfrm>
            <a:off x="1601640" y="687240"/>
            <a:ext cx="7543800" cy="6391440"/>
          </a:xfrm>
          <a:prstGeom prst="rect">
            <a:avLst/>
          </a:prstGeom>
          <a:ln w="0">
            <a:noFill/>
          </a:ln>
        </p:spPr>
      </p:pic>
      <p:sp>
        <p:nvSpPr>
          <p:cNvPr id="51" name=""/>
          <p:cNvSpPr/>
          <p:nvPr/>
        </p:nvSpPr>
        <p:spPr>
          <a:xfrm>
            <a:off x="447480" y="457200"/>
            <a:ext cx="122328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Dpl 310K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2" name="" descr=""/>
          <p:cNvPicPr/>
          <p:nvPr/>
        </p:nvPicPr>
        <p:blipFill>
          <a:blip r:embed="rId1"/>
          <a:stretch/>
        </p:blipFill>
        <p:spPr>
          <a:xfrm>
            <a:off x="1346040" y="757080"/>
            <a:ext cx="7543800" cy="6391440"/>
          </a:xfrm>
          <a:prstGeom prst="rect">
            <a:avLst/>
          </a:prstGeom>
          <a:ln w="0">
            <a:noFill/>
          </a:ln>
        </p:spPr>
      </p:pic>
      <p:sp>
        <p:nvSpPr>
          <p:cNvPr id="53" name=""/>
          <p:cNvSpPr/>
          <p:nvPr/>
        </p:nvSpPr>
        <p:spPr>
          <a:xfrm>
            <a:off x="448200" y="457200"/>
            <a:ext cx="122328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Dpl 350K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" name="" descr=""/>
          <p:cNvPicPr/>
          <p:nvPr/>
        </p:nvPicPr>
        <p:blipFill>
          <a:blip r:embed="rId1"/>
          <a:stretch/>
        </p:blipFill>
        <p:spPr>
          <a:xfrm>
            <a:off x="1830240" y="925560"/>
            <a:ext cx="7560000" cy="6391080"/>
          </a:xfrm>
          <a:prstGeom prst="rect">
            <a:avLst/>
          </a:prstGeom>
          <a:ln w="0">
            <a:noFill/>
          </a:ln>
        </p:spPr>
      </p:pic>
      <p:sp>
        <p:nvSpPr>
          <p:cNvPr id="55" name=""/>
          <p:cNvSpPr/>
          <p:nvPr/>
        </p:nvSpPr>
        <p:spPr>
          <a:xfrm>
            <a:off x="448200" y="457200"/>
            <a:ext cx="1223280" cy="358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5000" bIns="45000" anchor="t">
            <a:spAutoFit/>
          </a:bodyPr>
          <a:p>
            <a:pPr>
              <a:lnSpc>
                <a:spcPct val="98000"/>
              </a:lnSpc>
              <a:tabLst>
                <a:tab algn="l" pos="0"/>
                <a:tab algn="l" pos="72396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  <a:tab algn="l" pos="96012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Bitstream Vera Sans"/>
              </a:rPr>
              <a:t>Dpl 450K</a:t>
            </a:r>
            <a:endParaRPr b="0" lang="en-US" sz="1800" spc="-1" strike="noStrike">
              <a:solidFill>
                <a:srgbClr val="000000"/>
              </a:solidFill>
              <a:latin typeface="Bitstream Vera Sans"/>
            </a:endParaRPr>
          </a:p>
        </p:txBody>
      </p:sp>
    </p:spTree>
  </p:cSld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6" name=""/>
          <p:cNvGrpSpPr/>
          <p:nvPr/>
        </p:nvGrpSpPr>
        <p:grpSpPr>
          <a:xfrm>
            <a:off x="576360" y="395280"/>
            <a:ext cx="8197920" cy="4303800"/>
            <a:chOff x="576360" y="395280"/>
            <a:chExt cx="8197920" cy="4303800"/>
          </a:xfrm>
        </p:grpSpPr>
        <p:grpSp>
          <p:nvGrpSpPr>
            <p:cNvPr id="57" name=""/>
            <p:cNvGrpSpPr/>
            <p:nvPr/>
          </p:nvGrpSpPr>
          <p:grpSpPr>
            <a:xfrm>
              <a:off x="576360" y="395280"/>
              <a:ext cx="8197920" cy="4303800"/>
              <a:chOff x="576360" y="395280"/>
              <a:chExt cx="8197920" cy="4303800"/>
            </a:xfrm>
          </p:grpSpPr>
          <p:pic>
            <p:nvPicPr>
              <p:cNvPr id="58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576360" y="684360"/>
                <a:ext cx="3373200" cy="4014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59" name="" descr=""/>
              <p:cNvPicPr/>
              <p:nvPr/>
            </p:nvPicPr>
            <p:blipFill>
              <a:blip r:embed="rId2"/>
              <a:stretch/>
            </p:blipFill>
            <p:spPr>
              <a:xfrm>
                <a:off x="5400720" y="684360"/>
                <a:ext cx="3373560" cy="40147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0" name=""/>
              <p:cNvSpPr/>
              <p:nvPr/>
            </p:nvSpPr>
            <p:spPr>
              <a:xfrm>
                <a:off x="2234520" y="395280"/>
                <a:ext cx="712440" cy="360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Arial"/>
                  </a:rPr>
                  <a:t>Prion</a:t>
                </a: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>
                <a:off x="6915240" y="395280"/>
                <a:ext cx="901440" cy="36000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800" spc="-1" strike="noStrike">
                    <a:solidFill>
                      <a:srgbClr val="ffffff"/>
                    </a:solidFill>
                    <a:latin typeface="Arial"/>
                  </a:rPr>
                  <a:t>Doppel</a:t>
                </a: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2" name=""/>
              <p:cNvSpPr/>
              <p:nvPr/>
            </p:nvSpPr>
            <p:spPr>
              <a:xfrm>
                <a:off x="1871640" y="4138560"/>
                <a:ext cx="1295280" cy="217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3" name=""/>
              <p:cNvSpPr/>
              <p:nvPr/>
            </p:nvSpPr>
            <p:spPr>
              <a:xfrm>
                <a:off x="6769080" y="4140360"/>
                <a:ext cx="1295280" cy="21744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>
                <a:off x="647640" y="1763640"/>
                <a:ext cx="360360" cy="1584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5" name=""/>
              <p:cNvSpPr/>
              <p:nvPr/>
            </p:nvSpPr>
            <p:spPr>
              <a:xfrm>
                <a:off x="5472000" y="1835280"/>
                <a:ext cx="360360" cy="1584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6" name=""/>
              <p:cNvSpPr/>
              <p:nvPr/>
            </p:nvSpPr>
            <p:spPr>
              <a:xfrm>
                <a:off x="2014920" y="4140360"/>
                <a:ext cx="1224720" cy="27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Arial"/>
                  </a:rPr>
                  <a:t>Cluster number</a:t>
                </a:r>
                <a:endParaRPr b="0" lang="en-US" sz="12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7" name=""/>
              <p:cNvSpPr/>
              <p:nvPr/>
            </p:nvSpPr>
            <p:spPr>
              <a:xfrm>
                <a:off x="6839280" y="4067280"/>
                <a:ext cx="1224720" cy="27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Arial"/>
                  </a:rPr>
                  <a:t>Cluster number</a:t>
                </a:r>
                <a:endParaRPr b="0" lang="en-US" sz="12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rot="16200000">
                <a:off x="242280" y="2383920"/>
                <a:ext cx="1224720" cy="27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Arial"/>
                  </a:rPr>
                  <a:t>Cluster number</a:t>
                </a:r>
                <a:endParaRPr b="0" lang="en-US" sz="12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69" name=""/>
              <p:cNvSpPr/>
              <p:nvPr/>
            </p:nvSpPr>
            <p:spPr>
              <a:xfrm rot="16200000">
                <a:off x="4995000" y="2383920"/>
                <a:ext cx="1224720" cy="2707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t">
                <a:spAutoFit/>
              </a:bodyPr>
              <a:p>
                <a:pPr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r>
                  <a:rPr b="0" lang="en-US" sz="1200" spc="-1" strike="noStrike">
                    <a:solidFill>
                      <a:srgbClr val="ffffff"/>
                    </a:solidFill>
                    <a:latin typeface="Arial"/>
                  </a:rPr>
                  <a:t>Cluster number</a:t>
                </a:r>
                <a:endParaRPr b="0" lang="en-US" sz="12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70" name=""/>
              <p:cNvSpPr/>
              <p:nvPr/>
            </p:nvSpPr>
            <p:spPr>
              <a:xfrm>
                <a:off x="1655640" y="4367160"/>
                <a:ext cx="505080" cy="144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71" name=""/>
              <p:cNvSpPr/>
              <p:nvPr/>
            </p:nvSpPr>
            <p:spPr>
              <a:xfrm>
                <a:off x="2952720" y="4427640"/>
                <a:ext cx="504720" cy="144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>
                <a:off x="6480000" y="4367160"/>
                <a:ext cx="505080" cy="144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  <p:sp>
            <p:nvSpPr>
              <p:cNvPr id="73" name=""/>
              <p:cNvSpPr/>
              <p:nvPr/>
            </p:nvSpPr>
            <p:spPr>
              <a:xfrm>
                <a:off x="7777080" y="4367160"/>
                <a:ext cx="505080" cy="144360"/>
              </a:xfrm>
              <a:prstGeom prst="rect">
                <a:avLst/>
              </a:prstGeom>
              <a:solidFill>
                <a:srgbClr val="ffffff"/>
              </a:solidFill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pPr algn="ctr">
                  <a:lnSpc>
                    <a:spcPct val="97000"/>
                  </a:lnSpc>
                  <a:tabLst>
                    <a:tab algn="l" pos="0"/>
                    <a:tab algn="l" pos="457200"/>
                    <a:tab algn="l" pos="914400"/>
                    <a:tab algn="l" pos="1371600"/>
                    <a:tab algn="l" pos="1828800"/>
                    <a:tab algn="l" pos="2286000"/>
                    <a:tab algn="l" pos="2743200"/>
                    <a:tab algn="l" pos="3200400"/>
                    <a:tab algn="l" pos="3657600"/>
                    <a:tab algn="l" pos="4114800"/>
                    <a:tab algn="l" pos="4572000"/>
                    <a:tab algn="l" pos="5029200"/>
                    <a:tab algn="l" pos="5486400"/>
                    <a:tab algn="l" pos="5943600"/>
                    <a:tab algn="l" pos="6400800"/>
                    <a:tab algn="l" pos="6858000"/>
                    <a:tab algn="l" pos="7315200"/>
                    <a:tab algn="l" pos="7772400"/>
                    <a:tab algn="l" pos="8229600"/>
                    <a:tab algn="l" pos="8686800"/>
                    <a:tab algn="l" pos="9144000"/>
                  </a:tabLst>
                </a:pPr>
                <a:endParaRPr b="0" lang="en-US" sz="1800" spc="-1" strike="noStrike">
                  <a:solidFill>
                    <a:srgbClr val="000000"/>
                  </a:solidFill>
                  <a:latin typeface="Bitstream Vera Sans"/>
                </a:endParaRPr>
              </a:p>
            </p:txBody>
          </p:sp>
        </p:grpSp>
        <p:sp>
          <p:nvSpPr>
            <p:cNvPr id="74" name=""/>
            <p:cNvSpPr/>
            <p:nvPr/>
          </p:nvSpPr>
          <p:spPr>
            <a:xfrm>
              <a:off x="1802160" y="4356000"/>
              <a:ext cx="23724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7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Bitstream Vera Sans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3024360" y="4356000"/>
              <a:ext cx="36036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7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1.4</a:t>
              </a:r>
              <a:endParaRPr b="0" lang="en-US" sz="800" spc="-1" strike="noStrike">
                <a:solidFill>
                  <a:srgbClr val="000000"/>
                </a:solidFill>
                <a:latin typeface="Bitstream Vera Sans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6626520" y="4356000"/>
              <a:ext cx="23724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97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Bitstream Vera Sans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7848720" y="4356000"/>
              <a:ext cx="360360" cy="211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97000"/>
                </a:lnSpc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0" lang="en-US" sz="800" spc="-1" strike="noStrike">
                  <a:solidFill>
                    <a:srgbClr val="ffffff"/>
                  </a:solidFill>
                  <a:latin typeface="Arial"/>
                </a:rPr>
                <a:t>1.4</a:t>
              </a:r>
              <a:endParaRPr b="0" lang="en-US" sz="800" spc="-1" strike="noStrike">
                <a:solidFill>
                  <a:srgbClr val="000000"/>
                </a:solidFill>
                <a:latin typeface="Bitstream Vera Sans"/>
              </a:endParaRPr>
            </a:p>
          </p:txBody>
        </p:sp>
      </p:grp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/>
  <dc:description/>
  <dc:language>en-US</dc:language>
  <cp:lastModifiedBy>giorgio</cp:lastModifiedBy>
  <dcterms:modified xsi:type="dcterms:W3CDTF">2006-06-23T09:17:26Z</dcterms:modified>
  <cp:revision>5</cp:revision>
  <dc:subject/>
  <dc:title>Diapositiva 1</dc:title>
</cp:coreProperties>
</file>